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6ABFD9-C1B1-428C-B4F9-3B673F008008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4FC3D1-F6B5-482F-95A3-4AD827E85207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E530F-97E0-4137-B3CA-2DC02136CD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86995-E832-49BB-AE65-2D65DB0386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F7B03-A896-480B-A20E-B281846BCE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DC690E-4826-459C-8DFA-82FBCEAF1A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9CA192-65DF-4464-89CB-B4B0D2660C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92339-EAB3-4E26-87ED-23266EFB91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AB782-6DCC-49C0-9FC7-5FB7F0FA65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BDCEF-6EE6-4E99-994C-73F586E8EE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2B310-2936-431E-B29A-5309511560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7B0A5-C195-4FC6-B470-CFFF534220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AEC34-34CC-4AC2-9F36-B301034BD0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E8C9C-3AC3-4E30-BD07-D97CFB039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A8A40A-6090-4D5B-B5FB-309A607E75EB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o 26"/>
          <p:cNvGrpSpPr/>
          <p:nvPr/>
        </p:nvGrpSpPr>
        <p:grpSpPr>
          <a:xfrm>
            <a:off x="428760" y="368280"/>
            <a:ext cx="8572320" cy="5694120"/>
            <a:chOff x="428760" y="368280"/>
            <a:chExt cx="8572320" cy="5694120"/>
          </a:xfrm>
        </p:grpSpPr>
        <p:pic>
          <p:nvPicPr>
            <p:cNvPr id="49" name="Picture 3" descr=""/>
            <p:cNvPicPr/>
            <p:nvPr/>
          </p:nvPicPr>
          <p:blipFill>
            <a:blip r:embed="rId1"/>
            <a:srcRect l="3416" t="8240" r="9200" b="9328"/>
            <a:stretch/>
          </p:blipFill>
          <p:spPr>
            <a:xfrm>
              <a:off x="1692360" y="642600"/>
              <a:ext cx="1871640" cy="216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2" descr=""/>
            <p:cNvPicPr/>
            <p:nvPr/>
          </p:nvPicPr>
          <p:blipFill>
            <a:blip r:embed="rId2"/>
            <a:srcRect l="0" t="0" r="0" b="10613"/>
            <a:stretch/>
          </p:blipFill>
          <p:spPr>
            <a:xfrm>
              <a:off x="428760" y="452160"/>
              <a:ext cx="121428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CasellaDiTesto 5"/>
            <p:cNvSpPr/>
            <p:nvPr/>
          </p:nvSpPr>
          <p:spPr>
            <a:xfrm>
              <a:off x="718560" y="380880"/>
              <a:ext cx="799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evr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asellaDiTesto 8"/>
            <p:cNvSpPr/>
            <p:nvPr/>
          </p:nvSpPr>
          <p:spPr>
            <a:xfrm>
              <a:off x="2334600" y="380880"/>
              <a:ext cx="88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armoni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2" descr=""/>
            <p:cNvPicPr/>
            <p:nvPr/>
          </p:nvPicPr>
          <p:blipFill>
            <a:blip r:embed="rId3"/>
            <a:srcRect l="0" t="0" r="0" b="10899"/>
            <a:stretch/>
          </p:blipFill>
          <p:spPr>
            <a:xfrm>
              <a:off x="428760" y="3331800"/>
              <a:ext cx="1285560" cy="219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CasellaDiTesto 11"/>
            <p:cNvSpPr/>
            <p:nvPr/>
          </p:nvSpPr>
          <p:spPr>
            <a:xfrm>
              <a:off x="813600" y="3166560"/>
              <a:ext cx="578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o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5" name="Picture 3" descr=""/>
            <p:cNvPicPr/>
            <p:nvPr/>
          </p:nvPicPr>
          <p:blipFill>
            <a:blip r:embed="rId4"/>
            <a:srcRect l="0" t="0" r="0" b="10613"/>
            <a:stretch/>
          </p:blipFill>
          <p:spPr>
            <a:xfrm>
              <a:off x="1643040" y="3321720"/>
              <a:ext cx="2000160" cy="2214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CasellaDiTesto 13"/>
            <p:cNvSpPr/>
            <p:nvPr/>
          </p:nvSpPr>
          <p:spPr>
            <a:xfrm>
              <a:off x="2147400" y="3166560"/>
              <a:ext cx="1098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wo-syllab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7" name="Picture 11" descr=""/>
            <p:cNvPicPr/>
            <p:nvPr/>
          </p:nvPicPr>
          <p:blipFill>
            <a:blip r:embed="rId5"/>
            <a:srcRect l="0" t="0" r="0" b="11107"/>
            <a:stretch/>
          </p:blipFill>
          <p:spPr>
            <a:xfrm>
              <a:off x="3714840" y="452160"/>
              <a:ext cx="142848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CasellaDiTesto 15"/>
            <p:cNvSpPr/>
            <p:nvPr/>
          </p:nvSpPr>
          <p:spPr>
            <a:xfrm>
              <a:off x="4147920" y="380880"/>
              <a:ext cx="74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pwar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Picture 15" descr=""/>
            <p:cNvPicPr/>
            <p:nvPr/>
          </p:nvPicPr>
          <p:blipFill>
            <a:blip r:embed="rId6"/>
            <a:srcRect l="0" t="0" r="0" b="11107"/>
            <a:stretch/>
          </p:blipFill>
          <p:spPr>
            <a:xfrm>
              <a:off x="3714840" y="3309480"/>
              <a:ext cx="164304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CasellaDiTesto 18"/>
            <p:cNvSpPr/>
            <p:nvPr/>
          </p:nvSpPr>
          <p:spPr>
            <a:xfrm>
              <a:off x="4332240" y="31762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Picture 17" descr=""/>
            <p:cNvPicPr/>
            <p:nvPr/>
          </p:nvPicPr>
          <p:blipFill>
            <a:blip r:embed="rId7"/>
            <a:srcRect l="0" t="0" r="0" b="11107"/>
            <a:stretch/>
          </p:blipFill>
          <p:spPr>
            <a:xfrm>
              <a:off x="5357880" y="3309480"/>
              <a:ext cx="171432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CasellaDiTesto 19"/>
            <p:cNvSpPr/>
            <p:nvPr/>
          </p:nvSpPr>
          <p:spPr>
            <a:xfrm>
              <a:off x="5745960" y="3166560"/>
              <a:ext cx="96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mposi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Picture 14" descr=""/>
            <p:cNvPicPr/>
            <p:nvPr/>
          </p:nvPicPr>
          <p:blipFill>
            <a:blip r:embed="rId8"/>
            <a:srcRect l="0" t="0" r="0" b="10899"/>
            <a:stretch/>
          </p:blipFill>
          <p:spPr>
            <a:xfrm>
              <a:off x="7000920" y="3309480"/>
              <a:ext cx="2000160" cy="22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4" descr=""/>
            <p:cNvPicPr/>
            <p:nvPr/>
          </p:nvPicPr>
          <p:blipFill>
            <a:blip r:embed="rId9"/>
            <a:srcRect l="0" t="0" r="0" b="10613"/>
            <a:stretch/>
          </p:blipFill>
          <p:spPr>
            <a:xfrm>
              <a:off x="5286600" y="452160"/>
              <a:ext cx="142848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CasellaDiTesto 24"/>
            <p:cNvSpPr/>
            <p:nvPr/>
          </p:nvSpPr>
          <p:spPr>
            <a:xfrm>
              <a:off x="5587560" y="380880"/>
              <a:ext cx="95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wnwar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6" name="Picture 2" descr=""/>
            <p:cNvPicPr/>
            <p:nvPr/>
          </p:nvPicPr>
          <p:blipFill>
            <a:blip r:embed="rId10"/>
            <a:srcRect l="0" t="0" r="0" b="10613"/>
            <a:stretch/>
          </p:blipFill>
          <p:spPr>
            <a:xfrm>
              <a:off x="7000920" y="452160"/>
              <a:ext cx="1714320" cy="228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CasellaDiTesto 26"/>
            <p:cNvSpPr/>
            <p:nvPr/>
          </p:nvSpPr>
          <p:spPr>
            <a:xfrm>
              <a:off x="7453440" y="368280"/>
              <a:ext cx="126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mple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498"/>
            <p:cNvSpPr/>
            <p:nvPr/>
          </p:nvSpPr>
          <p:spPr>
            <a:xfrm>
              <a:off x="714240" y="5785920"/>
              <a:ext cx="1000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igure S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CasellaDiTesto 22"/>
            <p:cNvSpPr/>
            <p:nvPr/>
          </p:nvSpPr>
          <p:spPr>
            <a:xfrm>
              <a:off x="7364880" y="3153960"/>
              <a:ext cx="1310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Frequency ste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6T08:57:07Z</dcterms:created>
  <dc:creator>Venerosi_Aldina</dc:creator>
  <dc:description/>
  <dc:language>en-US</dc:language>
  <cp:lastModifiedBy> </cp:lastModifiedBy>
  <dcterms:modified xsi:type="dcterms:W3CDTF">2008-08-01T12:16:05Z</dcterms:modified>
  <cp:revision>3</cp:revision>
  <dc:subject/>
  <dc:title>Diapositiva 1</dc:title>
</cp:coreProperties>
</file>